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7: </a:t>
            </a:r>
            <a:r>
              <a:rPr lang="en-GB" sz="1600" dirty="0" smtClean="0"/>
              <a:t>3D model structure and validation of APC gene. A) Wild (Template </a:t>
            </a:r>
            <a:r>
              <a:rPr lang="en-US" sz="1600" dirty="0"/>
              <a:t>3nmz_A</a:t>
            </a:r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/>
              <a:t>3nmz_A</a:t>
            </a:r>
            <a:r>
              <a:rPr lang="en-US" sz="1600" dirty="0" smtClean="0"/>
              <a:t>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71538" y="428604"/>
            <a:ext cx="2671781" cy="24288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71415"/>
            <a:ext cx="3143272" cy="300039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071538" y="3229957"/>
            <a:ext cx="2647954" cy="2556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1" y="3214686"/>
            <a:ext cx="3143272" cy="279082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1</cp:revision>
  <dcterms:created xsi:type="dcterms:W3CDTF">2018-05-10T07:33:24Z</dcterms:created>
  <dcterms:modified xsi:type="dcterms:W3CDTF">2018-05-29T06:50:38Z</dcterms:modified>
</cp:coreProperties>
</file>